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>
      <p:cViewPr varScale="1">
        <p:scale>
          <a:sx n="89" d="100"/>
          <a:sy n="89" d="100"/>
        </p:scale>
        <p:origin x="120" y="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27741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380924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713955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207611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30623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13336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509936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833716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293464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2028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506406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08523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25396" y="228600"/>
            <a:ext cx="3918204" cy="914400"/>
          </a:xfrm>
        </p:spPr>
        <p:txBody>
          <a:bodyPr>
            <a:normAutofit/>
          </a:bodyPr>
          <a:lstStyle/>
          <a:p>
            <a:pPr algn="l"/>
            <a:r>
              <a:rPr lang="en-US" sz="2000" b="1" dirty="0" err="1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S2</a:t>
            </a:r>
            <a:r>
              <a:rPr lang="en-US" sz="2000" b="1" dirty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 Figure: volcano plot </a:t>
            </a:r>
            <a:endParaRPr 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1" y="2083118"/>
            <a:ext cx="5257800" cy="3743325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4419600" y="2464117"/>
            <a:ext cx="4343400" cy="1828800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6553200" y="2235517"/>
            <a:ext cx="1981200" cy="20574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416296" y="5955268"/>
            <a:ext cx="1447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prstClr val="black"/>
                </a:solidFill>
              </a:rPr>
              <a:t>Fold Change</a:t>
            </a:r>
            <a:endParaRPr lang="en-US" dirty="0">
              <a:solidFill>
                <a:prstClr val="black"/>
              </a:solidFill>
            </a:endParaRPr>
          </a:p>
        </p:txBody>
      </p:sp>
      <p:sp>
        <p:nvSpPr>
          <p:cNvPr id="5" name="Striped Right Arrow 4"/>
          <p:cNvSpPr/>
          <p:nvPr/>
        </p:nvSpPr>
        <p:spPr>
          <a:xfrm>
            <a:off x="6858000" y="5978842"/>
            <a:ext cx="685800" cy="309182"/>
          </a:xfrm>
          <a:prstGeom prst="stripedRightArrow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9" name="Striped Right Arrow 8"/>
          <p:cNvSpPr/>
          <p:nvPr/>
        </p:nvSpPr>
        <p:spPr>
          <a:xfrm rot="10800000">
            <a:off x="4648200" y="5978842"/>
            <a:ext cx="685800" cy="309182"/>
          </a:xfrm>
          <a:prstGeom prst="stripedRightArrow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3015734" y="3727251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prstClr val="black"/>
                </a:solidFill>
              </a:rPr>
              <a:t>p-value</a:t>
            </a:r>
            <a:endParaRPr lang="en-US" dirty="0">
              <a:solidFill>
                <a:prstClr val="black"/>
              </a:solidFill>
            </a:endParaRPr>
          </a:p>
        </p:txBody>
      </p:sp>
      <p:sp>
        <p:nvSpPr>
          <p:cNvPr id="8" name="Striped Right Arrow 7"/>
          <p:cNvSpPr/>
          <p:nvPr/>
        </p:nvSpPr>
        <p:spPr>
          <a:xfrm rot="16200000">
            <a:off x="1797130" y="3118247"/>
            <a:ext cx="1219201" cy="1130141"/>
          </a:xfrm>
          <a:prstGeom prst="striped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025396" y="4445318"/>
            <a:ext cx="11750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C00000"/>
                </a:solidFill>
              </a:rPr>
              <a:t>More </a:t>
            </a:r>
          </a:p>
          <a:p>
            <a:r>
              <a:rPr lang="en-US" dirty="0">
                <a:solidFill>
                  <a:srgbClr val="C00000"/>
                </a:solidFill>
              </a:rPr>
              <a:t>Significant</a:t>
            </a:r>
            <a:endParaRPr lang="en-US" dirty="0">
              <a:solidFill>
                <a:srgbClr val="C00000"/>
              </a:solidFill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4616198" y="2235517"/>
            <a:ext cx="800099" cy="2057400"/>
          </a:xfrm>
          <a:prstGeom prst="rect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083550" y="1748654"/>
            <a:ext cx="12252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</a:rPr>
              <a:t>Significantly </a:t>
            </a:r>
          </a:p>
          <a:p>
            <a:r>
              <a:rPr lang="en-US" sz="1200" b="1" dirty="0">
                <a:solidFill>
                  <a:prstClr val="black"/>
                </a:solidFill>
              </a:rPr>
              <a:t>up-regulated</a:t>
            </a:r>
            <a:endParaRPr lang="en-US" sz="1200" b="1" dirty="0">
              <a:solidFill>
                <a:prstClr val="black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495800" y="1750666"/>
            <a:ext cx="23622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</a:rPr>
              <a:t>Significantly </a:t>
            </a:r>
          </a:p>
          <a:p>
            <a:r>
              <a:rPr lang="en-US" sz="1200" b="1" dirty="0">
                <a:solidFill>
                  <a:prstClr val="black"/>
                </a:solidFill>
              </a:rPr>
              <a:t>down-regulated</a:t>
            </a:r>
            <a:endParaRPr lang="en-US" sz="1200" b="1" dirty="0">
              <a:solidFill>
                <a:prstClr val="black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996441" y="838200"/>
            <a:ext cx="2194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taset-1: </a:t>
            </a: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GSE</a:t>
            </a: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36842</a:t>
            </a:r>
            <a:endParaRPr 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72394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1_Office Theme</vt:lpstr>
      <vt:lpstr>S2 Figure: volcano plot 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2 Figure: volcano plot </dc:title>
  <dc:creator>Douglas Surwilo</dc:creator>
  <cp:lastModifiedBy>Douglas Surwilo</cp:lastModifiedBy>
  <cp:revision>1</cp:revision>
  <dcterms:created xsi:type="dcterms:W3CDTF">2015-12-11T19:50:51Z</dcterms:created>
  <dcterms:modified xsi:type="dcterms:W3CDTF">2015-12-11T19:51:04Z</dcterms:modified>
</cp:coreProperties>
</file>